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72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389" autoAdjust="0"/>
    <p:restoredTop sz="94660"/>
  </p:normalViewPr>
  <p:slideViewPr>
    <p:cSldViewPr snapToGrid="0">
      <p:cViewPr varScale="1">
        <p:scale>
          <a:sx n="82" d="100"/>
          <a:sy n="82" d="100"/>
        </p:scale>
        <p:origin x="749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7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73074A-3CDC-A8C7-3846-9C3168BA6FCE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Antimicrobial pharmacokinetics in pediatric patients on kidney replacement therapy: a comprehensive review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67110FE-CFDF-BF93-A923-3253F9E75B29}"/>
              </a:ext>
            </a:extLst>
          </p:cNvPr>
          <p:cNvSpPr txBox="1"/>
          <p:nvPr/>
        </p:nvSpPr>
        <p:spPr>
          <a:xfrm>
            <a:off x="183463" y="1258206"/>
            <a:ext cx="7968646" cy="452431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b="1" dirty="0">
                <a:solidFill>
                  <a:srgbClr val="003969"/>
                </a:solidFill>
              </a:rPr>
              <a:t>Key points</a:t>
            </a:r>
            <a:r>
              <a:rPr lang="en-GB" dirty="0">
                <a:solidFill>
                  <a:srgbClr val="003969"/>
                </a:solidFill>
              </a:rPr>
              <a:t>: </a:t>
            </a:r>
          </a:p>
          <a:p>
            <a:r>
              <a:rPr lang="en-GB" dirty="0">
                <a:solidFill>
                  <a:srgbClr val="003969"/>
                </a:solidFill>
              </a:rPr>
              <a:t>1. Many dosing recommendations for pediatric patients on dialysis are extrapolated from adult studies; however there are significant differences in physiology and pharmacokinetic (PK) parameters between pediatric and adult populations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2. We found 56 original human studies evaluating the PK of antimicrobials in pediatric patients on dialysis (CKRT, n=41; HD, n=4; PD, n=11). Seven antimicrobials (amoxicillin, ampicillin, ceftaroline, ciprofloxacin, ganciclovir, metronidazole, and trimethoprim-sulfamethoxazole) had no PK data in pediatric patients on dialysis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3. The majority of studies were single case reports and small case series, with findings that cannot be broadly applied.</a:t>
            </a:r>
          </a:p>
          <a:p>
            <a:endParaRPr lang="en-GB" dirty="0">
              <a:solidFill>
                <a:srgbClr val="003969"/>
              </a:solidFill>
            </a:endParaRPr>
          </a:p>
          <a:p>
            <a:r>
              <a:rPr lang="en-GB" dirty="0">
                <a:solidFill>
                  <a:srgbClr val="003969"/>
                </a:solidFill>
              </a:rPr>
              <a:t>4. Existing drug PK data in pediatric patients on dialysis are not currently robust enough to account for prescription variations in dosing recommendations.</a:t>
            </a:r>
          </a:p>
          <a:p>
            <a:endParaRPr lang="en-GB" dirty="0">
              <a:solidFill>
                <a:srgbClr val="003969"/>
              </a:solidFill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6418948-B141-D43D-69AA-F2059F8E9C4E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einert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8C3F199-12A1-FD9E-3F46-B336BCE4A5C9}"/>
              </a:ext>
            </a:extLst>
          </p:cNvPr>
          <p:cNvSpPr txBox="1"/>
          <p:nvPr/>
        </p:nvSpPr>
        <p:spPr>
          <a:xfrm>
            <a:off x="173448" y="5719172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Antimicrobial pharmacokinetics in pediatric patients on dialysis are understudied, despite this population being at increased risk of infection and vulnerable to drug toxicity.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1F4EFC5-9B2C-30C5-0B84-41D133EF3D12}"/>
              </a:ext>
            </a:extLst>
          </p:cNvPr>
          <p:cNvSpPr txBox="1"/>
          <p:nvPr/>
        </p:nvSpPr>
        <p:spPr>
          <a:xfrm>
            <a:off x="8149693" y="5100944"/>
            <a:ext cx="4045771" cy="76944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1400" b="1" dirty="0"/>
              <a:t>Number of studies identified for each modality type</a:t>
            </a:r>
            <a:endParaRPr lang="en-US" dirty="0">
              <a:ea typeface="Calibri" panose="020F0502020204030204"/>
              <a:cs typeface="Calibri" panose="020F0502020204030204"/>
            </a:endParaRPr>
          </a:p>
          <a:p>
            <a:r>
              <a:rPr lang="en-GB" sz="1200" dirty="0">
                <a:solidFill>
                  <a:srgbClr val="000000"/>
                </a:solidFill>
                <a:ea typeface="Calibri"/>
                <a:cs typeface="Calibri"/>
              </a:rPr>
              <a:t>*One of the CKRT studies covered 3 antimicrobial agents </a:t>
            </a:r>
          </a:p>
          <a:p>
            <a:endParaRPr lang="en-GB" dirty="0">
              <a:solidFill>
                <a:srgbClr val="003969"/>
              </a:solidFill>
              <a:ea typeface="Calibri" panose="020F0502020204030204"/>
              <a:cs typeface="Calibri" panose="020F0502020204030204"/>
            </a:endParaRPr>
          </a:p>
        </p:txBody>
      </p:sp>
      <p:pic>
        <p:nvPicPr>
          <p:cNvPr id="7" name="Picture 6" descr="A table of antimicrobial agents&#10;&#10;AI-generated content may be incorrect.">
            <a:extLst>
              <a:ext uri="{FF2B5EF4-FFF2-40B4-BE49-F238E27FC236}">
                <a16:creationId xmlns:a16="http://schemas.microsoft.com/office/drawing/2014/main" id="{098B6DD0-D4A2-8C4B-3BDB-DEE6F2BCCB8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06" t="5018" r="4318" b="6120"/>
          <a:stretch>
            <a:fillRect/>
          </a:stretch>
        </p:blipFill>
        <p:spPr>
          <a:xfrm>
            <a:off x="8229601" y="1142823"/>
            <a:ext cx="3790950" cy="39574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48924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16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115</cp:revision>
  <dcterms:created xsi:type="dcterms:W3CDTF">2019-06-13T12:30:18Z</dcterms:created>
  <dcterms:modified xsi:type="dcterms:W3CDTF">2025-11-17T22:45:02Z</dcterms:modified>
</cp:coreProperties>
</file>